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897E9-9F19-491E-9BB6-32BBE6853F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B7874-1E38-4990-BE63-8417BDAF0C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C4DAE-B6C4-40DC-BB81-A811CEF437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25B66-6B70-4778-866E-0FB702CFD8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C274F-BB7E-4B56-A25A-164F2B82EA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56A35-3A4C-4A9A-AB6A-584F842B4D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2D557-7732-4502-B018-C5FA9CC7B5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9E13C-AEEF-4983-9BFD-9AA78CD283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99A33-81D8-4E49-BB7D-0B4DD85ECF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B9DA0-C98B-4C9A-81C9-F73EEF4351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06FA7-82EA-412E-AC31-32FB4282A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B4CBA-21E4-416D-9ADF-A0CE5DC2AE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37E840-8439-4D69-ADD6-F97CCD4E055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874880" y="3516480"/>
            <a:ext cx="3108240" cy="21873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343400" y="3733920"/>
            <a:ext cx="914400" cy="228600"/>
          </a:xfrm>
          <a:prstGeom prst="ellips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343400" y="3728880"/>
            <a:ext cx="685800" cy="1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327560" y="3681360"/>
            <a:ext cx="933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cc0000"/>
                </a:solidFill>
                <a:latin typeface="Arial Unicode MS"/>
              </a:rPr>
              <a:t>RNAi Screen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212280" y="5791320"/>
            <a:ext cx="587520" cy="2462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FK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438280" y="3517920"/>
            <a:ext cx="876600" cy="152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382840" y="3486240"/>
            <a:ext cx="1006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8d8a00"/>
                </a:solidFill>
                <a:latin typeface="Arial Unicode MS"/>
              </a:rPr>
              <a:t>Mukerji Mod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H="1">
            <a:off x="3187800" y="3117960"/>
            <a:ext cx="133200" cy="1371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29240" y="5632560"/>
            <a:ext cx="496080" cy="2462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V="1">
            <a:off x="2438280" y="5181480"/>
            <a:ext cx="38124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714680" y="4051440"/>
            <a:ext cx="1028520" cy="291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3505320" y="5486040"/>
            <a:ext cx="0" cy="304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4114440" y="4191120"/>
            <a:ext cx="1219320" cy="152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419720" y="289080"/>
            <a:ext cx="213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ukerji et al., Supporting Figure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H="1" flipV="1">
            <a:off x="4038120" y="5181480"/>
            <a:ext cx="76212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354920" y="5359320"/>
            <a:ext cx="706680" cy="8553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2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P5K1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b1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L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LB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289120" y="3352680"/>
            <a:ext cx="616680" cy="207360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BM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JAK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F3B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HX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NR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NP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YL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NR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FR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F3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173240" y="3695760"/>
            <a:ext cx="609120" cy="70308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C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C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059280" y="3124080"/>
            <a:ext cx="609120" cy="2462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C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354920" y="3244680"/>
            <a:ext cx="579960" cy="3985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1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a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3505320" y="3657600"/>
            <a:ext cx="838080" cy="685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0T20:20:49Z</dcterms:created>
  <dc:creator>Partners Information Systems</dc:creator>
  <dc:description/>
  <dc:language>en-US</dc:language>
  <cp:lastModifiedBy>Partners Information Systems</cp:lastModifiedBy>
  <dcterms:modified xsi:type="dcterms:W3CDTF">2012-02-11T00:28:03Z</dcterms:modified>
  <cp:revision>9</cp:revision>
  <dc:subject/>
  <dc:title>Slide 1</dc:title>
</cp:coreProperties>
</file>